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1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2.xml" ContentType="application/vnd.openxmlformats-officedocument.drawingml.chartshapes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0"/>
  </p:notesMasterIdLst>
  <p:sldIdLst>
    <p:sldId id="275" r:id="rId2"/>
    <p:sldId id="267" r:id="rId3"/>
    <p:sldId id="273" r:id="rId4"/>
    <p:sldId id="269" r:id="rId5"/>
    <p:sldId id="256" r:id="rId6"/>
    <p:sldId id="257" r:id="rId7"/>
    <p:sldId id="259" r:id="rId8"/>
    <p:sldId id="258" r:id="rId9"/>
    <p:sldId id="260" r:id="rId10"/>
    <p:sldId id="261" r:id="rId11"/>
    <p:sldId id="262" r:id="rId12"/>
    <p:sldId id="263" r:id="rId13"/>
    <p:sldId id="264" r:id="rId14"/>
    <p:sldId id="272" r:id="rId15"/>
    <p:sldId id="268" r:id="rId16"/>
    <p:sldId id="270" r:id="rId17"/>
    <p:sldId id="271" r:id="rId18"/>
    <p:sldId id="274" r:id="rId1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2639" autoAdjust="0"/>
  </p:normalViewPr>
  <p:slideViewPr>
    <p:cSldViewPr snapToGrid="0">
      <p:cViewPr varScale="1">
        <p:scale>
          <a:sx n="82" d="100"/>
          <a:sy n="82" d="100"/>
        </p:scale>
        <p:origin x="691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gglinsky\Desktop\HPATs%20Protein%20Binding\HPAT%20Protein%20Binding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gglinsky\Desktop\2017%20Human%20Specific%20Chromatin\2017%20PanLineage%20Precursors\HPAT%20Protein%20Binding%20Copy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gglinsky\Desktop\2017%20Human%20Specific%20Chromatin\2017%20PanLineage%20Precursors\HPAT%20Protein%20Binding%20Copy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800" b="1">
                <a:solidFill>
                  <a:sysClr val="windowText" lastClr="000000"/>
                </a:solidFill>
              </a:rPr>
              <a:t>EIGHTEEN</a:t>
            </a:r>
            <a:r>
              <a:rPr lang="en-US" sz="1800" b="1" baseline="0">
                <a:solidFill>
                  <a:sysClr val="windowText" lastClr="000000"/>
                </a:solidFill>
              </a:rPr>
              <a:t> COMMON HPAT-BINDING PROTEINS</a:t>
            </a:r>
            <a:endParaRPr lang="en-US" sz="1800" b="1">
              <a:solidFill>
                <a:sysClr val="windowText" lastClr="000000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0.16295783992217766"/>
          <c:y val="0.12623057952556085"/>
          <c:w val="0.82091766279971135"/>
          <c:h val="0.57239545818088733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Sheet4!$I$1</c:f>
              <c:strCache>
                <c:ptCount val="1"/>
                <c:pt idx="0">
                  <c:v>HPAT2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cat>
            <c:strRef>
              <c:f>Sheet4!$H$2:$H$20</c:f>
              <c:strCache>
                <c:ptCount val="19"/>
                <c:pt idx="0">
                  <c:v>TTYH2</c:v>
                </c:pt>
                <c:pt idx="1">
                  <c:v>TARBP2</c:v>
                </c:pt>
                <c:pt idx="2">
                  <c:v>OBFC2B/NABP2</c:v>
                </c:pt>
                <c:pt idx="3">
                  <c:v>KCNAB1_1</c:v>
                </c:pt>
                <c:pt idx="4">
                  <c:v>KCNAB1_3</c:v>
                </c:pt>
                <c:pt idx="5">
                  <c:v>RBMS3</c:v>
                </c:pt>
                <c:pt idx="6">
                  <c:v>ZADH2</c:v>
                </c:pt>
                <c:pt idx="7">
                  <c:v>CIRBP</c:v>
                </c:pt>
                <c:pt idx="8">
                  <c:v>RBPMS</c:v>
                </c:pt>
                <c:pt idx="9">
                  <c:v>QKI</c:v>
                </c:pt>
                <c:pt idx="10">
                  <c:v>KHDRBS2</c:v>
                </c:pt>
                <c:pt idx="11">
                  <c:v>ZNF533/ZNF385B</c:v>
                </c:pt>
                <c:pt idx="12">
                  <c:v>ELAVL3</c:v>
                </c:pt>
                <c:pt idx="13">
                  <c:v>GIMAP4</c:v>
                </c:pt>
                <c:pt idx="14">
                  <c:v>TIAL1</c:v>
                </c:pt>
                <c:pt idx="15">
                  <c:v>PHTF2</c:v>
                </c:pt>
                <c:pt idx="16">
                  <c:v>TMEM254</c:v>
                </c:pt>
                <c:pt idx="17">
                  <c:v>ANAPC16</c:v>
                </c:pt>
                <c:pt idx="18">
                  <c:v>PRPF31</c:v>
                </c:pt>
              </c:strCache>
            </c:strRef>
          </c:cat>
          <c:val>
            <c:numRef>
              <c:f>Sheet4!$I$2:$I$20</c:f>
              <c:numCache>
                <c:formatCode>General</c:formatCode>
                <c:ptCount val="19"/>
                <c:pt idx="0">
                  <c:v>59477</c:v>
                </c:pt>
                <c:pt idx="1">
                  <c:v>58397</c:v>
                </c:pt>
                <c:pt idx="2">
                  <c:v>34544</c:v>
                </c:pt>
                <c:pt idx="3">
                  <c:v>33880</c:v>
                </c:pt>
                <c:pt idx="4">
                  <c:v>25647</c:v>
                </c:pt>
                <c:pt idx="5">
                  <c:v>22468</c:v>
                </c:pt>
                <c:pt idx="6">
                  <c:v>20528</c:v>
                </c:pt>
                <c:pt idx="7">
                  <c:v>10508</c:v>
                </c:pt>
                <c:pt idx="8">
                  <c:v>9728</c:v>
                </c:pt>
                <c:pt idx="9">
                  <c:v>7550</c:v>
                </c:pt>
                <c:pt idx="10">
                  <c:v>10395</c:v>
                </c:pt>
                <c:pt idx="11">
                  <c:v>7901</c:v>
                </c:pt>
                <c:pt idx="12">
                  <c:v>5266</c:v>
                </c:pt>
                <c:pt idx="13">
                  <c:v>5185</c:v>
                </c:pt>
                <c:pt idx="14">
                  <c:v>3019</c:v>
                </c:pt>
                <c:pt idx="15">
                  <c:v>2942</c:v>
                </c:pt>
                <c:pt idx="16">
                  <c:v>1995</c:v>
                </c:pt>
              </c:numCache>
            </c:numRef>
          </c:val>
        </c:ser>
        <c:ser>
          <c:idx val="1"/>
          <c:order val="1"/>
          <c:tx>
            <c:strRef>
              <c:f>Sheet4!$J$1</c:f>
              <c:strCache>
                <c:ptCount val="1"/>
                <c:pt idx="0">
                  <c:v>HPAT3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accent1"/>
              </a:solidFill>
            </a:ln>
            <a:effectLst/>
            <a:sp3d>
              <a:contourClr>
                <a:schemeClr val="accent1"/>
              </a:contourClr>
            </a:sp3d>
          </c:spPr>
          <c:invertIfNegative val="0"/>
          <c:cat>
            <c:strRef>
              <c:f>Sheet4!$H$2:$H$20</c:f>
              <c:strCache>
                <c:ptCount val="19"/>
                <c:pt idx="0">
                  <c:v>TTYH2</c:v>
                </c:pt>
                <c:pt idx="1">
                  <c:v>TARBP2</c:v>
                </c:pt>
                <c:pt idx="2">
                  <c:v>OBFC2B/NABP2</c:v>
                </c:pt>
                <c:pt idx="3">
                  <c:v>KCNAB1_1</c:v>
                </c:pt>
                <c:pt idx="4">
                  <c:v>KCNAB1_3</c:v>
                </c:pt>
                <c:pt idx="5">
                  <c:v>RBMS3</c:v>
                </c:pt>
                <c:pt idx="6">
                  <c:v>ZADH2</c:v>
                </c:pt>
                <c:pt idx="7">
                  <c:v>CIRBP</c:v>
                </c:pt>
                <c:pt idx="8">
                  <c:v>RBPMS</c:v>
                </c:pt>
                <c:pt idx="9">
                  <c:v>QKI</c:v>
                </c:pt>
                <c:pt idx="10">
                  <c:v>KHDRBS2</c:v>
                </c:pt>
                <c:pt idx="11">
                  <c:v>ZNF533/ZNF385B</c:v>
                </c:pt>
                <c:pt idx="12">
                  <c:v>ELAVL3</c:v>
                </c:pt>
                <c:pt idx="13">
                  <c:v>GIMAP4</c:v>
                </c:pt>
                <c:pt idx="14">
                  <c:v>TIAL1</c:v>
                </c:pt>
                <c:pt idx="15">
                  <c:v>PHTF2</c:v>
                </c:pt>
                <c:pt idx="16">
                  <c:v>TMEM254</c:v>
                </c:pt>
                <c:pt idx="17">
                  <c:v>ANAPC16</c:v>
                </c:pt>
                <c:pt idx="18">
                  <c:v>PRPF31</c:v>
                </c:pt>
              </c:strCache>
            </c:strRef>
          </c:cat>
          <c:val>
            <c:numRef>
              <c:f>Sheet4!$J$2:$J$20</c:f>
              <c:numCache>
                <c:formatCode>General</c:formatCode>
                <c:ptCount val="19"/>
                <c:pt idx="0">
                  <c:v>24013</c:v>
                </c:pt>
                <c:pt idx="1">
                  <c:v>30553</c:v>
                </c:pt>
                <c:pt idx="2">
                  <c:v>11880</c:v>
                </c:pt>
                <c:pt idx="3">
                  <c:v>2654</c:v>
                </c:pt>
                <c:pt idx="4">
                  <c:v>8728</c:v>
                </c:pt>
                <c:pt idx="5">
                  <c:v>16988</c:v>
                </c:pt>
                <c:pt idx="6">
                  <c:v>23690</c:v>
                </c:pt>
                <c:pt idx="7">
                  <c:v>2854</c:v>
                </c:pt>
                <c:pt idx="8">
                  <c:v>10831</c:v>
                </c:pt>
                <c:pt idx="9">
                  <c:v>3125</c:v>
                </c:pt>
                <c:pt idx="16">
                  <c:v>9356</c:v>
                </c:pt>
                <c:pt idx="17">
                  <c:v>4422</c:v>
                </c:pt>
                <c:pt idx="18">
                  <c:v>2697</c:v>
                </c:pt>
              </c:numCache>
            </c:numRef>
          </c:val>
        </c:ser>
        <c:ser>
          <c:idx val="2"/>
          <c:order val="2"/>
          <c:tx>
            <c:strRef>
              <c:f>Sheet4!$K$1</c:f>
              <c:strCache>
                <c:ptCount val="1"/>
                <c:pt idx="0">
                  <c:v>HPAT5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chemeClr val="accent1"/>
              </a:solidFill>
            </a:ln>
            <a:effectLst/>
            <a:sp3d>
              <a:contourClr>
                <a:schemeClr val="accent1"/>
              </a:contourClr>
            </a:sp3d>
          </c:spPr>
          <c:invertIfNegative val="0"/>
          <c:cat>
            <c:strRef>
              <c:f>Sheet4!$H$2:$H$20</c:f>
              <c:strCache>
                <c:ptCount val="19"/>
                <c:pt idx="0">
                  <c:v>TTYH2</c:v>
                </c:pt>
                <c:pt idx="1">
                  <c:v>TARBP2</c:v>
                </c:pt>
                <c:pt idx="2">
                  <c:v>OBFC2B/NABP2</c:v>
                </c:pt>
                <c:pt idx="3">
                  <c:v>KCNAB1_1</c:v>
                </c:pt>
                <c:pt idx="4">
                  <c:v>KCNAB1_3</c:v>
                </c:pt>
                <c:pt idx="5">
                  <c:v>RBMS3</c:v>
                </c:pt>
                <c:pt idx="6">
                  <c:v>ZADH2</c:v>
                </c:pt>
                <c:pt idx="7">
                  <c:v>CIRBP</c:v>
                </c:pt>
                <c:pt idx="8">
                  <c:v>RBPMS</c:v>
                </c:pt>
                <c:pt idx="9">
                  <c:v>QKI</c:v>
                </c:pt>
                <c:pt idx="10">
                  <c:v>KHDRBS2</c:v>
                </c:pt>
                <c:pt idx="11">
                  <c:v>ZNF533/ZNF385B</c:v>
                </c:pt>
                <c:pt idx="12">
                  <c:v>ELAVL3</c:v>
                </c:pt>
                <c:pt idx="13">
                  <c:v>GIMAP4</c:v>
                </c:pt>
                <c:pt idx="14">
                  <c:v>TIAL1</c:v>
                </c:pt>
                <c:pt idx="15">
                  <c:v>PHTF2</c:v>
                </c:pt>
                <c:pt idx="16">
                  <c:v>TMEM254</c:v>
                </c:pt>
                <c:pt idx="17">
                  <c:v>ANAPC16</c:v>
                </c:pt>
                <c:pt idx="18">
                  <c:v>PRPF31</c:v>
                </c:pt>
              </c:strCache>
            </c:strRef>
          </c:cat>
          <c:val>
            <c:numRef>
              <c:f>Sheet4!$K$2:$K$20</c:f>
              <c:numCache>
                <c:formatCode>General</c:formatCode>
                <c:ptCount val="19"/>
                <c:pt idx="0">
                  <c:v>43290</c:v>
                </c:pt>
                <c:pt idx="1">
                  <c:v>46722</c:v>
                </c:pt>
                <c:pt idx="2">
                  <c:v>32188</c:v>
                </c:pt>
                <c:pt idx="3">
                  <c:v>10851</c:v>
                </c:pt>
                <c:pt idx="4">
                  <c:v>24096</c:v>
                </c:pt>
                <c:pt idx="5">
                  <c:v>23170</c:v>
                </c:pt>
                <c:pt idx="6">
                  <c:v>21063</c:v>
                </c:pt>
                <c:pt idx="7">
                  <c:v>2983</c:v>
                </c:pt>
                <c:pt idx="8">
                  <c:v>6113</c:v>
                </c:pt>
                <c:pt idx="9">
                  <c:v>4517</c:v>
                </c:pt>
                <c:pt idx="10">
                  <c:v>10941</c:v>
                </c:pt>
                <c:pt idx="11">
                  <c:v>2574</c:v>
                </c:pt>
                <c:pt idx="12">
                  <c:v>1951</c:v>
                </c:pt>
                <c:pt idx="13">
                  <c:v>2684</c:v>
                </c:pt>
                <c:pt idx="14">
                  <c:v>1583</c:v>
                </c:pt>
                <c:pt idx="15">
                  <c:v>1911</c:v>
                </c:pt>
                <c:pt idx="17">
                  <c:v>2094</c:v>
                </c:pt>
                <c:pt idx="18">
                  <c:v>228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278171592"/>
        <c:axId val="278171976"/>
        <c:axId val="0"/>
      </c:bar3DChart>
      <c:catAx>
        <c:axId val="2781715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8171976"/>
        <c:crosses val="autoZero"/>
        <c:auto val="1"/>
        <c:lblAlgn val="ctr"/>
        <c:lblOffset val="100"/>
        <c:tickLblSkip val="1"/>
        <c:noMultiLvlLbl val="0"/>
      </c:catAx>
      <c:valAx>
        <c:axId val="27817197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2000" b="1">
                    <a:solidFill>
                      <a:sysClr val="windowText" lastClr="000000"/>
                    </a:solidFill>
                  </a:rPr>
                  <a:t>PROTEIN</a:t>
                </a:r>
                <a:r>
                  <a:rPr lang="en-US" sz="2000" b="1" baseline="0">
                    <a:solidFill>
                      <a:sysClr val="windowText" lastClr="000000"/>
                    </a:solidFill>
                  </a:rPr>
                  <a:t> BINDING</a:t>
                </a:r>
                <a:endParaRPr lang="en-US" sz="2000" b="1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4.0493841296164887E-2"/>
              <c:y val="0.261938970696966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0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8171592"/>
        <c:crossesAt val="1"/>
        <c:crossBetween val="between"/>
      </c:valAx>
      <c:spPr>
        <a:noFill/>
        <a:ln>
          <a:noFill/>
        </a:ln>
        <a:effectLst/>
      </c:spPr>
    </c:plotArea>
    <c:legend>
      <c:legendPos val="t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800" b="1">
                <a:solidFill>
                  <a:sysClr val="windowText" lastClr="000000"/>
                </a:solidFill>
              </a:rPr>
              <a:t>EIGHTEEN</a:t>
            </a:r>
            <a:r>
              <a:rPr lang="en-US" sz="1800" b="1" baseline="0">
                <a:solidFill>
                  <a:sysClr val="windowText" lastClr="000000"/>
                </a:solidFill>
              </a:rPr>
              <a:t> COMMON HPAT-BINDING PROTEINS</a:t>
            </a:r>
            <a:endParaRPr lang="en-US" sz="1800" b="1">
              <a:solidFill>
                <a:sysClr val="windowText" lastClr="000000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0.16295783992217766"/>
          <c:y val="0.12623057952556085"/>
          <c:w val="0.82091766279971135"/>
          <c:h val="0.57239545818088733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Sheet4!$H$1</c:f>
              <c:strCache>
                <c:ptCount val="1"/>
                <c:pt idx="0">
                  <c:v>HPAT2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cat>
            <c:strRef>
              <c:f>Sheet4!$G$2:$G$20</c:f>
              <c:strCache>
                <c:ptCount val="19"/>
                <c:pt idx="0">
                  <c:v>TTYH2</c:v>
                </c:pt>
                <c:pt idx="1">
                  <c:v>TARBP2</c:v>
                </c:pt>
                <c:pt idx="2">
                  <c:v>OBFC2B/NABP2</c:v>
                </c:pt>
                <c:pt idx="3">
                  <c:v>KCNAB1_1</c:v>
                </c:pt>
                <c:pt idx="4">
                  <c:v>KCNAB1_3</c:v>
                </c:pt>
                <c:pt idx="5">
                  <c:v>RBMS3</c:v>
                </c:pt>
                <c:pt idx="6">
                  <c:v>ZADH2</c:v>
                </c:pt>
                <c:pt idx="7">
                  <c:v>CIRBP</c:v>
                </c:pt>
                <c:pt idx="8">
                  <c:v>RBPMS</c:v>
                </c:pt>
                <c:pt idx="9">
                  <c:v>QKI</c:v>
                </c:pt>
                <c:pt idx="10">
                  <c:v>KHDRBS2</c:v>
                </c:pt>
                <c:pt idx="11">
                  <c:v>ZNF533/ZNF385B</c:v>
                </c:pt>
                <c:pt idx="12">
                  <c:v>ELAVL3</c:v>
                </c:pt>
                <c:pt idx="13">
                  <c:v>GIMAP4</c:v>
                </c:pt>
                <c:pt idx="14">
                  <c:v>TIAL1</c:v>
                </c:pt>
                <c:pt idx="15">
                  <c:v>PHTF2</c:v>
                </c:pt>
                <c:pt idx="16">
                  <c:v>TMEM254</c:v>
                </c:pt>
                <c:pt idx="17">
                  <c:v>ANAPC16</c:v>
                </c:pt>
                <c:pt idx="18">
                  <c:v>PRPF31</c:v>
                </c:pt>
              </c:strCache>
            </c:strRef>
          </c:cat>
          <c:val>
            <c:numRef>
              <c:f>Sheet4!$H$2:$H$20</c:f>
              <c:numCache>
                <c:formatCode>General</c:formatCode>
                <c:ptCount val="19"/>
                <c:pt idx="0">
                  <c:v>59477</c:v>
                </c:pt>
                <c:pt idx="1">
                  <c:v>58397</c:v>
                </c:pt>
                <c:pt idx="2">
                  <c:v>34544</c:v>
                </c:pt>
                <c:pt idx="3">
                  <c:v>33880</c:v>
                </c:pt>
                <c:pt idx="4">
                  <c:v>25647</c:v>
                </c:pt>
                <c:pt idx="5">
                  <c:v>22468</c:v>
                </c:pt>
                <c:pt idx="6">
                  <c:v>20528</c:v>
                </c:pt>
                <c:pt idx="7">
                  <c:v>10508</c:v>
                </c:pt>
                <c:pt idx="8">
                  <c:v>9728</c:v>
                </c:pt>
                <c:pt idx="9">
                  <c:v>7550</c:v>
                </c:pt>
                <c:pt idx="10">
                  <c:v>10395</c:v>
                </c:pt>
                <c:pt idx="11">
                  <c:v>7901</c:v>
                </c:pt>
                <c:pt idx="12">
                  <c:v>5266</c:v>
                </c:pt>
                <c:pt idx="13">
                  <c:v>5185</c:v>
                </c:pt>
                <c:pt idx="14">
                  <c:v>3019</c:v>
                </c:pt>
                <c:pt idx="15">
                  <c:v>2942</c:v>
                </c:pt>
                <c:pt idx="16">
                  <c:v>1995</c:v>
                </c:pt>
              </c:numCache>
            </c:numRef>
          </c:val>
        </c:ser>
        <c:ser>
          <c:idx val="1"/>
          <c:order val="1"/>
          <c:tx>
            <c:strRef>
              <c:f>Sheet4!$I$1</c:f>
              <c:strCache>
                <c:ptCount val="1"/>
                <c:pt idx="0">
                  <c:v>HPAT3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accent1"/>
              </a:solidFill>
            </a:ln>
            <a:effectLst/>
            <a:sp3d>
              <a:contourClr>
                <a:schemeClr val="accent1"/>
              </a:contourClr>
            </a:sp3d>
          </c:spPr>
          <c:invertIfNegative val="0"/>
          <c:cat>
            <c:strRef>
              <c:f>Sheet4!$G$2:$G$20</c:f>
              <c:strCache>
                <c:ptCount val="19"/>
                <c:pt idx="0">
                  <c:v>TTYH2</c:v>
                </c:pt>
                <c:pt idx="1">
                  <c:v>TARBP2</c:v>
                </c:pt>
                <c:pt idx="2">
                  <c:v>OBFC2B/NABP2</c:v>
                </c:pt>
                <c:pt idx="3">
                  <c:v>KCNAB1_1</c:v>
                </c:pt>
                <c:pt idx="4">
                  <c:v>KCNAB1_3</c:v>
                </c:pt>
                <c:pt idx="5">
                  <c:v>RBMS3</c:v>
                </c:pt>
                <c:pt idx="6">
                  <c:v>ZADH2</c:v>
                </c:pt>
                <c:pt idx="7">
                  <c:v>CIRBP</c:v>
                </c:pt>
                <c:pt idx="8">
                  <c:v>RBPMS</c:v>
                </c:pt>
                <c:pt idx="9">
                  <c:v>QKI</c:v>
                </c:pt>
                <c:pt idx="10">
                  <c:v>KHDRBS2</c:v>
                </c:pt>
                <c:pt idx="11">
                  <c:v>ZNF533/ZNF385B</c:v>
                </c:pt>
                <c:pt idx="12">
                  <c:v>ELAVL3</c:v>
                </c:pt>
                <c:pt idx="13">
                  <c:v>GIMAP4</c:v>
                </c:pt>
                <c:pt idx="14">
                  <c:v>TIAL1</c:v>
                </c:pt>
                <c:pt idx="15">
                  <c:v>PHTF2</c:v>
                </c:pt>
                <c:pt idx="16">
                  <c:v>TMEM254</c:v>
                </c:pt>
                <c:pt idx="17">
                  <c:v>ANAPC16</c:v>
                </c:pt>
                <c:pt idx="18">
                  <c:v>PRPF31</c:v>
                </c:pt>
              </c:strCache>
            </c:strRef>
          </c:cat>
          <c:val>
            <c:numRef>
              <c:f>Sheet4!$I$2:$I$20</c:f>
              <c:numCache>
                <c:formatCode>General</c:formatCode>
                <c:ptCount val="19"/>
                <c:pt idx="0">
                  <c:v>24013</c:v>
                </c:pt>
                <c:pt idx="1">
                  <c:v>30553</c:v>
                </c:pt>
                <c:pt idx="2">
                  <c:v>11880</c:v>
                </c:pt>
                <c:pt idx="3">
                  <c:v>2654</c:v>
                </c:pt>
                <c:pt idx="4">
                  <c:v>8728</c:v>
                </c:pt>
                <c:pt idx="5">
                  <c:v>16988</c:v>
                </c:pt>
                <c:pt idx="6">
                  <c:v>23690</c:v>
                </c:pt>
                <c:pt idx="7">
                  <c:v>2854</c:v>
                </c:pt>
                <c:pt idx="8">
                  <c:v>10831</c:v>
                </c:pt>
                <c:pt idx="9">
                  <c:v>3125</c:v>
                </c:pt>
                <c:pt idx="16">
                  <c:v>9356</c:v>
                </c:pt>
                <c:pt idx="17">
                  <c:v>4422</c:v>
                </c:pt>
                <c:pt idx="18">
                  <c:v>2697</c:v>
                </c:pt>
              </c:numCache>
            </c:numRef>
          </c:val>
        </c:ser>
        <c:ser>
          <c:idx val="2"/>
          <c:order val="2"/>
          <c:tx>
            <c:strRef>
              <c:f>Sheet4!$J$1</c:f>
              <c:strCache>
                <c:ptCount val="1"/>
                <c:pt idx="0">
                  <c:v>HPAT5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chemeClr val="accent1"/>
              </a:solidFill>
            </a:ln>
            <a:effectLst/>
            <a:sp3d>
              <a:contourClr>
                <a:schemeClr val="accent1"/>
              </a:contourClr>
            </a:sp3d>
          </c:spPr>
          <c:invertIfNegative val="0"/>
          <c:cat>
            <c:strRef>
              <c:f>Sheet4!$G$2:$G$20</c:f>
              <c:strCache>
                <c:ptCount val="19"/>
                <c:pt idx="0">
                  <c:v>TTYH2</c:v>
                </c:pt>
                <c:pt idx="1">
                  <c:v>TARBP2</c:v>
                </c:pt>
                <c:pt idx="2">
                  <c:v>OBFC2B/NABP2</c:v>
                </c:pt>
                <c:pt idx="3">
                  <c:v>KCNAB1_1</c:v>
                </c:pt>
                <c:pt idx="4">
                  <c:v>KCNAB1_3</c:v>
                </c:pt>
                <c:pt idx="5">
                  <c:v>RBMS3</c:v>
                </c:pt>
                <c:pt idx="6">
                  <c:v>ZADH2</c:v>
                </c:pt>
                <c:pt idx="7">
                  <c:v>CIRBP</c:v>
                </c:pt>
                <c:pt idx="8">
                  <c:v>RBPMS</c:v>
                </c:pt>
                <c:pt idx="9">
                  <c:v>QKI</c:v>
                </c:pt>
                <c:pt idx="10">
                  <c:v>KHDRBS2</c:v>
                </c:pt>
                <c:pt idx="11">
                  <c:v>ZNF533/ZNF385B</c:v>
                </c:pt>
                <c:pt idx="12">
                  <c:v>ELAVL3</c:v>
                </c:pt>
                <c:pt idx="13">
                  <c:v>GIMAP4</c:v>
                </c:pt>
                <c:pt idx="14">
                  <c:v>TIAL1</c:v>
                </c:pt>
                <c:pt idx="15">
                  <c:v>PHTF2</c:v>
                </c:pt>
                <c:pt idx="16">
                  <c:v>TMEM254</c:v>
                </c:pt>
                <c:pt idx="17">
                  <c:v>ANAPC16</c:v>
                </c:pt>
                <c:pt idx="18">
                  <c:v>PRPF31</c:v>
                </c:pt>
              </c:strCache>
            </c:strRef>
          </c:cat>
          <c:val>
            <c:numRef>
              <c:f>Sheet4!$J$2:$J$20</c:f>
              <c:numCache>
                <c:formatCode>General</c:formatCode>
                <c:ptCount val="19"/>
                <c:pt idx="0">
                  <c:v>43290</c:v>
                </c:pt>
                <c:pt idx="1">
                  <c:v>46722</c:v>
                </c:pt>
                <c:pt idx="2">
                  <c:v>32188</c:v>
                </c:pt>
                <c:pt idx="3">
                  <c:v>10851</c:v>
                </c:pt>
                <c:pt idx="4">
                  <c:v>24096</c:v>
                </c:pt>
                <c:pt idx="5">
                  <c:v>23170</c:v>
                </c:pt>
                <c:pt idx="6">
                  <c:v>21063</c:v>
                </c:pt>
                <c:pt idx="7">
                  <c:v>2983</c:v>
                </c:pt>
                <c:pt idx="8">
                  <c:v>6113</c:v>
                </c:pt>
                <c:pt idx="9">
                  <c:v>4517</c:v>
                </c:pt>
                <c:pt idx="10">
                  <c:v>10941</c:v>
                </c:pt>
                <c:pt idx="11">
                  <c:v>2574</c:v>
                </c:pt>
                <c:pt idx="12">
                  <c:v>1951</c:v>
                </c:pt>
                <c:pt idx="13">
                  <c:v>2684</c:v>
                </c:pt>
                <c:pt idx="14">
                  <c:v>1583</c:v>
                </c:pt>
                <c:pt idx="15">
                  <c:v>1911</c:v>
                </c:pt>
                <c:pt idx="17">
                  <c:v>2094</c:v>
                </c:pt>
                <c:pt idx="18">
                  <c:v>228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277590792"/>
        <c:axId val="279137992"/>
        <c:axId val="0"/>
      </c:bar3DChart>
      <c:catAx>
        <c:axId val="2775907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9137992"/>
        <c:crosses val="autoZero"/>
        <c:auto val="1"/>
        <c:lblAlgn val="ctr"/>
        <c:lblOffset val="100"/>
        <c:tickLblSkip val="1"/>
        <c:noMultiLvlLbl val="0"/>
      </c:catAx>
      <c:valAx>
        <c:axId val="27913799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2000" b="1">
                    <a:solidFill>
                      <a:sysClr val="windowText" lastClr="000000"/>
                    </a:solidFill>
                  </a:rPr>
                  <a:t>PROTEIN</a:t>
                </a:r>
                <a:r>
                  <a:rPr lang="en-US" sz="2000" b="1" baseline="0">
                    <a:solidFill>
                      <a:sysClr val="windowText" lastClr="000000"/>
                    </a:solidFill>
                  </a:rPr>
                  <a:t> BINDING</a:t>
                </a:r>
                <a:endParaRPr lang="en-US" sz="2000" b="1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4.0493841296164887E-2"/>
              <c:y val="0.261938970696966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0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7590792"/>
        <c:crossesAt val="1"/>
        <c:crossBetween val="between"/>
      </c:valAx>
      <c:spPr>
        <a:noFill/>
        <a:ln>
          <a:noFill/>
        </a:ln>
        <a:effectLst/>
      </c:spPr>
    </c:plotArea>
    <c:legend>
      <c:legendPos val="t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800" b="1">
                <a:solidFill>
                  <a:sysClr val="windowText" lastClr="000000"/>
                </a:solidFill>
              </a:rPr>
              <a:t>EIGHTEEN</a:t>
            </a:r>
            <a:r>
              <a:rPr lang="en-US" sz="1800" b="1" baseline="0">
                <a:solidFill>
                  <a:sysClr val="windowText" lastClr="000000"/>
                </a:solidFill>
              </a:rPr>
              <a:t> COMMON HPAT-BINDING PROTEINS</a:t>
            </a:r>
            <a:endParaRPr lang="en-US" sz="1800" b="1">
              <a:solidFill>
                <a:sysClr val="windowText" lastClr="000000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0.16295783992217766"/>
          <c:y val="0.12623057952556085"/>
          <c:w val="0.82091766279971135"/>
          <c:h val="0.57239545818088733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Sheet4!$H$1</c:f>
              <c:strCache>
                <c:ptCount val="1"/>
                <c:pt idx="0">
                  <c:v>HPAT2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cat>
            <c:strRef>
              <c:f>Sheet4!$G$2:$G$20</c:f>
              <c:strCache>
                <c:ptCount val="19"/>
                <c:pt idx="0">
                  <c:v>TTYH2</c:v>
                </c:pt>
                <c:pt idx="1">
                  <c:v>TARBP2</c:v>
                </c:pt>
                <c:pt idx="2">
                  <c:v>OBFC2B/NABP2</c:v>
                </c:pt>
                <c:pt idx="3">
                  <c:v>KCNAB1_1</c:v>
                </c:pt>
                <c:pt idx="4">
                  <c:v>KCNAB1_3</c:v>
                </c:pt>
                <c:pt idx="5">
                  <c:v>RBMS3</c:v>
                </c:pt>
                <c:pt idx="6">
                  <c:v>ZADH2</c:v>
                </c:pt>
                <c:pt idx="7">
                  <c:v>CIRBP</c:v>
                </c:pt>
                <c:pt idx="8">
                  <c:v>RBPMS</c:v>
                </c:pt>
                <c:pt idx="9">
                  <c:v>QKI</c:v>
                </c:pt>
                <c:pt idx="10">
                  <c:v>KHDRBS2</c:v>
                </c:pt>
                <c:pt idx="11">
                  <c:v>ZNF533/ZNF385B</c:v>
                </c:pt>
                <c:pt idx="12">
                  <c:v>ELAVL3</c:v>
                </c:pt>
                <c:pt idx="13">
                  <c:v>GIMAP4</c:v>
                </c:pt>
                <c:pt idx="14">
                  <c:v>TIAL1</c:v>
                </c:pt>
                <c:pt idx="15">
                  <c:v>PHTF2</c:v>
                </c:pt>
                <c:pt idx="16">
                  <c:v>TMEM254</c:v>
                </c:pt>
                <c:pt idx="17">
                  <c:v>ANAPC16</c:v>
                </c:pt>
                <c:pt idx="18">
                  <c:v>PRPF31</c:v>
                </c:pt>
              </c:strCache>
            </c:strRef>
          </c:cat>
          <c:val>
            <c:numRef>
              <c:f>Sheet4!$H$2:$H$20</c:f>
              <c:numCache>
                <c:formatCode>General</c:formatCode>
                <c:ptCount val="19"/>
                <c:pt idx="0">
                  <c:v>59477</c:v>
                </c:pt>
                <c:pt idx="1">
                  <c:v>58397</c:v>
                </c:pt>
                <c:pt idx="2">
                  <c:v>34544</c:v>
                </c:pt>
                <c:pt idx="3">
                  <c:v>33880</c:v>
                </c:pt>
                <c:pt idx="4">
                  <c:v>25647</c:v>
                </c:pt>
                <c:pt idx="5">
                  <c:v>22468</c:v>
                </c:pt>
                <c:pt idx="6">
                  <c:v>20528</c:v>
                </c:pt>
                <c:pt idx="7">
                  <c:v>10508</c:v>
                </c:pt>
                <c:pt idx="8">
                  <c:v>9728</c:v>
                </c:pt>
                <c:pt idx="9">
                  <c:v>7550</c:v>
                </c:pt>
                <c:pt idx="10">
                  <c:v>10395</c:v>
                </c:pt>
                <c:pt idx="11">
                  <c:v>7901</c:v>
                </c:pt>
                <c:pt idx="12">
                  <c:v>5266</c:v>
                </c:pt>
                <c:pt idx="13">
                  <c:v>5185</c:v>
                </c:pt>
                <c:pt idx="14">
                  <c:v>3019</c:v>
                </c:pt>
                <c:pt idx="15">
                  <c:v>2942</c:v>
                </c:pt>
                <c:pt idx="16">
                  <c:v>1995</c:v>
                </c:pt>
              </c:numCache>
            </c:numRef>
          </c:val>
        </c:ser>
        <c:ser>
          <c:idx val="1"/>
          <c:order val="1"/>
          <c:tx>
            <c:strRef>
              <c:f>Sheet4!$I$1</c:f>
              <c:strCache>
                <c:ptCount val="1"/>
                <c:pt idx="0">
                  <c:v>HPAT3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accent1"/>
              </a:solidFill>
            </a:ln>
            <a:effectLst/>
            <a:sp3d>
              <a:contourClr>
                <a:schemeClr val="accent1"/>
              </a:contourClr>
            </a:sp3d>
          </c:spPr>
          <c:invertIfNegative val="0"/>
          <c:cat>
            <c:strRef>
              <c:f>Sheet4!$G$2:$G$20</c:f>
              <c:strCache>
                <c:ptCount val="19"/>
                <c:pt idx="0">
                  <c:v>TTYH2</c:v>
                </c:pt>
                <c:pt idx="1">
                  <c:v>TARBP2</c:v>
                </c:pt>
                <c:pt idx="2">
                  <c:v>OBFC2B/NABP2</c:v>
                </c:pt>
                <c:pt idx="3">
                  <c:v>KCNAB1_1</c:v>
                </c:pt>
                <c:pt idx="4">
                  <c:v>KCNAB1_3</c:v>
                </c:pt>
                <c:pt idx="5">
                  <c:v>RBMS3</c:v>
                </c:pt>
                <c:pt idx="6">
                  <c:v>ZADH2</c:v>
                </c:pt>
                <c:pt idx="7">
                  <c:v>CIRBP</c:v>
                </c:pt>
                <c:pt idx="8">
                  <c:v>RBPMS</c:v>
                </c:pt>
                <c:pt idx="9">
                  <c:v>QKI</c:v>
                </c:pt>
                <c:pt idx="10">
                  <c:v>KHDRBS2</c:v>
                </c:pt>
                <c:pt idx="11">
                  <c:v>ZNF533/ZNF385B</c:v>
                </c:pt>
                <c:pt idx="12">
                  <c:v>ELAVL3</c:v>
                </c:pt>
                <c:pt idx="13">
                  <c:v>GIMAP4</c:v>
                </c:pt>
                <c:pt idx="14">
                  <c:v>TIAL1</c:v>
                </c:pt>
                <c:pt idx="15">
                  <c:v>PHTF2</c:v>
                </c:pt>
                <c:pt idx="16">
                  <c:v>TMEM254</c:v>
                </c:pt>
                <c:pt idx="17">
                  <c:v>ANAPC16</c:v>
                </c:pt>
                <c:pt idx="18">
                  <c:v>PRPF31</c:v>
                </c:pt>
              </c:strCache>
            </c:strRef>
          </c:cat>
          <c:val>
            <c:numRef>
              <c:f>Sheet4!$I$2:$I$20</c:f>
              <c:numCache>
                <c:formatCode>General</c:formatCode>
                <c:ptCount val="19"/>
                <c:pt idx="0">
                  <c:v>24013</c:v>
                </c:pt>
                <c:pt idx="1">
                  <c:v>30553</c:v>
                </c:pt>
                <c:pt idx="2">
                  <c:v>11880</c:v>
                </c:pt>
                <c:pt idx="3">
                  <c:v>2654</c:v>
                </c:pt>
                <c:pt idx="4">
                  <c:v>8728</c:v>
                </c:pt>
                <c:pt idx="5">
                  <c:v>16988</c:v>
                </c:pt>
                <c:pt idx="6">
                  <c:v>23690</c:v>
                </c:pt>
                <c:pt idx="7">
                  <c:v>2854</c:v>
                </c:pt>
                <c:pt idx="8">
                  <c:v>10831</c:v>
                </c:pt>
                <c:pt idx="9">
                  <c:v>3125</c:v>
                </c:pt>
                <c:pt idx="16">
                  <c:v>9356</c:v>
                </c:pt>
                <c:pt idx="17">
                  <c:v>4422</c:v>
                </c:pt>
                <c:pt idx="18">
                  <c:v>2697</c:v>
                </c:pt>
              </c:numCache>
            </c:numRef>
          </c:val>
        </c:ser>
        <c:ser>
          <c:idx val="2"/>
          <c:order val="2"/>
          <c:tx>
            <c:strRef>
              <c:f>Sheet4!$J$1</c:f>
              <c:strCache>
                <c:ptCount val="1"/>
                <c:pt idx="0">
                  <c:v>HPAT5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chemeClr val="accent1"/>
              </a:solidFill>
            </a:ln>
            <a:effectLst/>
            <a:sp3d>
              <a:contourClr>
                <a:schemeClr val="accent1"/>
              </a:contourClr>
            </a:sp3d>
          </c:spPr>
          <c:invertIfNegative val="0"/>
          <c:cat>
            <c:strRef>
              <c:f>Sheet4!$G$2:$G$20</c:f>
              <c:strCache>
                <c:ptCount val="19"/>
                <c:pt idx="0">
                  <c:v>TTYH2</c:v>
                </c:pt>
                <c:pt idx="1">
                  <c:v>TARBP2</c:v>
                </c:pt>
                <c:pt idx="2">
                  <c:v>OBFC2B/NABP2</c:v>
                </c:pt>
                <c:pt idx="3">
                  <c:v>KCNAB1_1</c:v>
                </c:pt>
                <c:pt idx="4">
                  <c:v>KCNAB1_3</c:v>
                </c:pt>
                <c:pt idx="5">
                  <c:v>RBMS3</c:v>
                </c:pt>
                <c:pt idx="6">
                  <c:v>ZADH2</c:v>
                </c:pt>
                <c:pt idx="7">
                  <c:v>CIRBP</c:v>
                </c:pt>
                <c:pt idx="8">
                  <c:v>RBPMS</c:v>
                </c:pt>
                <c:pt idx="9">
                  <c:v>QKI</c:v>
                </c:pt>
                <c:pt idx="10">
                  <c:v>KHDRBS2</c:v>
                </c:pt>
                <c:pt idx="11">
                  <c:v>ZNF533/ZNF385B</c:v>
                </c:pt>
                <c:pt idx="12">
                  <c:v>ELAVL3</c:v>
                </c:pt>
                <c:pt idx="13">
                  <c:v>GIMAP4</c:v>
                </c:pt>
                <c:pt idx="14">
                  <c:v>TIAL1</c:v>
                </c:pt>
                <c:pt idx="15">
                  <c:v>PHTF2</c:v>
                </c:pt>
                <c:pt idx="16">
                  <c:v>TMEM254</c:v>
                </c:pt>
                <c:pt idx="17">
                  <c:v>ANAPC16</c:v>
                </c:pt>
                <c:pt idx="18">
                  <c:v>PRPF31</c:v>
                </c:pt>
              </c:strCache>
            </c:strRef>
          </c:cat>
          <c:val>
            <c:numRef>
              <c:f>Sheet4!$J$2:$J$20</c:f>
              <c:numCache>
                <c:formatCode>General</c:formatCode>
                <c:ptCount val="19"/>
                <c:pt idx="0">
                  <c:v>43290</c:v>
                </c:pt>
                <c:pt idx="1">
                  <c:v>46722</c:v>
                </c:pt>
                <c:pt idx="2">
                  <c:v>32188</c:v>
                </c:pt>
                <c:pt idx="3">
                  <c:v>10851</c:v>
                </c:pt>
                <c:pt idx="4">
                  <c:v>24096</c:v>
                </c:pt>
                <c:pt idx="5">
                  <c:v>23170</c:v>
                </c:pt>
                <c:pt idx="6">
                  <c:v>21063</c:v>
                </c:pt>
                <c:pt idx="7">
                  <c:v>2983</c:v>
                </c:pt>
                <c:pt idx="8">
                  <c:v>6113</c:v>
                </c:pt>
                <c:pt idx="9">
                  <c:v>4517</c:v>
                </c:pt>
                <c:pt idx="10">
                  <c:v>10941</c:v>
                </c:pt>
                <c:pt idx="11">
                  <c:v>2574</c:v>
                </c:pt>
                <c:pt idx="12">
                  <c:v>1951</c:v>
                </c:pt>
                <c:pt idx="13">
                  <c:v>2684</c:v>
                </c:pt>
                <c:pt idx="14">
                  <c:v>1583</c:v>
                </c:pt>
                <c:pt idx="15">
                  <c:v>1911</c:v>
                </c:pt>
                <c:pt idx="17">
                  <c:v>2094</c:v>
                </c:pt>
                <c:pt idx="18">
                  <c:v>228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278230608"/>
        <c:axId val="278232176"/>
        <c:axId val="0"/>
      </c:bar3DChart>
      <c:catAx>
        <c:axId val="2782306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8232176"/>
        <c:crosses val="autoZero"/>
        <c:auto val="1"/>
        <c:lblAlgn val="ctr"/>
        <c:lblOffset val="100"/>
        <c:tickLblSkip val="1"/>
        <c:noMultiLvlLbl val="0"/>
      </c:catAx>
      <c:valAx>
        <c:axId val="27823217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2000" b="1">
                    <a:solidFill>
                      <a:sysClr val="windowText" lastClr="000000"/>
                    </a:solidFill>
                  </a:rPr>
                  <a:t>PROTEIN</a:t>
                </a:r>
                <a:r>
                  <a:rPr lang="en-US" sz="2000" b="1" baseline="0">
                    <a:solidFill>
                      <a:sysClr val="windowText" lastClr="000000"/>
                    </a:solidFill>
                  </a:rPr>
                  <a:t> BINDING</a:t>
                </a:r>
                <a:endParaRPr lang="en-US" sz="2000" b="1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4.0493841296164887E-2"/>
              <c:y val="0.261938970696966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0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8230608"/>
        <c:crossesAt val="1"/>
        <c:crossBetween val="between"/>
      </c:valAx>
      <c:spPr>
        <a:noFill/>
        <a:ln>
          <a:noFill/>
        </a:ln>
        <a:effectLst/>
      </c:spPr>
    </c:plotArea>
    <c:legend>
      <c:legendPos val="t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2199</cdr:x>
      <cdr:y>0.11175</cdr:y>
    </cdr:from>
    <cdr:to>
      <cdr:x>0.24689</cdr:x>
      <cdr:y>0.13467</cdr:y>
    </cdr:to>
    <cdr:sp macro="" textlink="">
      <cdr:nvSpPr>
        <cdr:cNvPr id="2" name="5-Point Star 1"/>
        <cdr:cNvSpPr/>
      </cdr:nvSpPr>
      <cdr:spPr>
        <a:xfrm xmlns:a="http://schemas.openxmlformats.org/drawingml/2006/main">
          <a:off x="1922972" y="700896"/>
          <a:ext cx="215660" cy="143774"/>
        </a:xfrm>
        <a:prstGeom xmlns:a="http://schemas.openxmlformats.org/drawingml/2006/main" prst="star5">
          <a:avLst/>
        </a:prstGeom>
        <a:solidFill xmlns:a="http://schemas.openxmlformats.org/drawingml/2006/main">
          <a:schemeClr val="tx1"/>
        </a:solidFill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46852</cdr:x>
      <cdr:y>0.53245</cdr:y>
    </cdr:from>
    <cdr:to>
      <cdr:x>0.49342</cdr:x>
      <cdr:y>0.55538</cdr:y>
    </cdr:to>
    <cdr:sp macro="" textlink="">
      <cdr:nvSpPr>
        <cdr:cNvPr id="3" name="5-Point Star 2"/>
        <cdr:cNvSpPr/>
      </cdr:nvSpPr>
      <cdr:spPr>
        <a:xfrm xmlns:a="http://schemas.openxmlformats.org/drawingml/2006/main">
          <a:off x="4058488" y="3339621"/>
          <a:ext cx="215660" cy="143774"/>
        </a:xfrm>
        <a:prstGeom xmlns:a="http://schemas.openxmlformats.org/drawingml/2006/main" prst="star5">
          <a:avLst/>
        </a:prstGeom>
        <a:solidFill xmlns:a="http://schemas.openxmlformats.org/drawingml/2006/main">
          <a:schemeClr val="tx1"/>
        </a:solidFill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51624</cdr:x>
      <cdr:y>0.53245</cdr:y>
    </cdr:from>
    <cdr:to>
      <cdr:x>0.54113</cdr:x>
      <cdr:y>0.55538</cdr:y>
    </cdr:to>
    <cdr:sp macro="" textlink="">
      <cdr:nvSpPr>
        <cdr:cNvPr id="4" name="5-Point Star 3"/>
        <cdr:cNvSpPr/>
      </cdr:nvSpPr>
      <cdr:spPr>
        <a:xfrm xmlns:a="http://schemas.openxmlformats.org/drawingml/2006/main">
          <a:off x="4471837" y="3339620"/>
          <a:ext cx="215660" cy="143774"/>
        </a:xfrm>
        <a:prstGeom xmlns:a="http://schemas.openxmlformats.org/drawingml/2006/main" prst="star5">
          <a:avLst/>
        </a:prstGeom>
        <a:solidFill xmlns:a="http://schemas.openxmlformats.org/drawingml/2006/main">
          <a:schemeClr val="tx1"/>
        </a:solidFill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55773</cdr:x>
      <cdr:y>0.53245</cdr:y>
    </cdr:from>
    <cdr:to>
      <cdr:x>0.58263</cdr:x>
      <cdr:y>0.55538</cdr:y>
    </cdr:to>
    <cdr:sp macro="" textlink="">
      <cdr:nvSpPr>
        <cdr:cNvPr id="5" name="5-Point Star 4"/>
        <cdr:cNvSpPr/>
      </cdr:nvSpPr>
      <cdr:spPr>
        <a:xfrm xmlns:a="http://schemas.openxmlformats.org/drawingml/2006/main">
          <a:off x="4831271" y="3339621"/>
          <a:ext cx="215660" cy="143774"/>
        </a:xfrm>
        <a:prstGeom xmlns:a="http://schemas.openxmlformats.org/drawingml/2006/main" prst="star5">
          <a:avLst/>
        </a:prstGeom>
        <a:solidFill xmlns:a="http://schemas.openxmlformats.org/drawingml/2006/main">
          <a:schemeClr val="tx1"/>
        </a:solidFill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76105</cdr:x>
      <cdr:y>0.61841</cdr:y>
    </cdr:from>
    <cdr:to>
      <cdr:x>0.78595</cdr:x>
      <cdr:y>0.64134</cdr:y>
    </cdr:to>
    <cdr:sp macro="" textlink="">
      <cdr:nvSpPr>
        <cdr:cNvPr id="6" name="5-Point Star 5"/>
        <cdr:cNvSpPr/>
      </cdr:nvSpPr>
      <cdr:spPr>
        <a:xfrm xmlns:a="http://schemas.openxmlformats.org/drawingml/2006/main">
          <a:off x="6592498" y="3878772"/>
          <a:ext cx="215660" cy="143774"/>
        </a:xfrm>
        <a:prstGeom xmlns:a="http://schemas.openxmlformats.org/drawingml/2006/main" prst="star5">
          <a:avLst/>
        </a:prstGeom>
        <a:solidFill xmlns:a="http://schemas.openxmlformats.org/drawingml/2006/main">
          <a:schemeClr val="tx1"/>
        </a:solidFill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89176</cdr:x>
      <cdr:y>0.61268</cdr:y>
    </cdr:from>
    <cdr:to>
      <cdr:x>0.91665</cdr:x>
      <cdr:y>0.63561</cdr:y>
    </cdr:to>
    <cdr:sp macro="" textlink="">
      <cdr:nvSpPr>
        <cdr:cNvPr id="7" name="5-Point Star 6"/>
        <cdr:cNvSpPr/>
      </cdr:nvSpPr>
      <cdr:spPr>
        <a:xfrm xmlns:a="http://schemas.openxmlformats.org/drawingml/2006/main">
          <a:off x="7724715" y="3842828"/>
          <a:ext cx="215660" cy="143774"/>
        </a:xfrm>
        <a:prstGeom xmlns:a="http://schemas.openxmlformats.org/drawingml/2006/main" prst="star5">
          <a:avLst/>
        </a:prstGeom>
        <a:solidFill xmlns:a="http://schemas.openxmlformats.org/drawingml/2006/main">
          <a:schemeClr val="tx1"/>
        </a:solidFill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93947</cdr:x>
      <cdr:y>0.61268</cdr:y>
    </cdr:from>
    <cdr:to>
      <cdr:x>0.96437</cdr:x>
      <cdr:y>0.63561</cdr:y>
    </cdr:to>
    <cdr:sp macro="" textlink="">
      <cdr:nvSpPr>
        <cdr:cNvPr id="8" name="5-Point Star 7"/>
        <cdr:cNvSpPr/>
      </cdr:nvSpPr>
      <cdr:spPr>
        <a:xfrm xmlns:a="http://schemas.openxmlformats.org/drawingml/2006/main">
          <a:off x="8138064" y="3842828"/>
          <a:ext cx="215660" cy="143774"/>
        </a:xfrm>
        <a:prstGeom xmlns:a="http://schemas.openxmlformats.org/drawingml/2006/main" prst="star5">
          <a:avLst/>
        </a:prstGeom>
        <a:solidFill xmlns:a="http://schemas.openxmlformats.org/drawingml/2006/main">
          <a:schemeClr val="tx1"/>
        </a:solidFill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2199</cdr:x>
      <cdr:y>0.11175</cdr:y>
    </cdr:from>
    <cdr:to>
      <cdr:x>0.24689</cdr:x>
      <cdr:y>0.13467</cdr:y>
    </cdr:to>
    <cdr:sp macro="" textlink="">
      <cdr:nvSpPr>
        <cdr:cNvPr id="2" name="5-Point Star 1"/>
        <cdr:cNvSpPr/>
      </cdr:nvSpPr>
      <cdr:spPr>
        <a:xfrm xmlns:a="http://schemas.openxmlformats.org/drawingml/2006/main">
          <a:off x="1922972" y="700896"/>
          <a:ext cx="215660" cy="143774"/>
        </a:xfrm>
        <a:prstGeom xmlns:a="http://schemas.openxmlformats.org/drawingml/2006/main" prst="star5">
          <a:avLst/>
        </a:prstGeom>
        <a:solidFill xmlns:a="http://schemas.openxmlformats.org/drawingml/2006/main">
          <a:schemeClr val="tx1"/>
        </a:solidFill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46852</cdr:x>
      <cdr:y>0.53245</cdr:y>
    </cdr:from>
    <cdr:to>
      <cdr:x>0.49342</cdr:x>
      <cdr:y>0.55538</cdr:y>
    </cdr:to>
    <cdr:sp macro="" textlink="">
      <cdr:nvSpPr>
        <cdr:cNvPr id="3" name="5-Point Star 2"/>
        <cdr:cNvSpPr/>
      </cdr:nvSpPr>
      <cdr:spPr>
        <a:xfrm xmlns:a="http://schemas.openxmlformats.org/drawingml/2006/main">
          <a:off x="4058488" y="3339621"/>
          <a:ext cx="215660" cy="143774"/>
        </a:xfrm>
        <a:prstGeom xmlns:a="http://schemas.openxmlformats.org/drawingml/2006/main" prst="star5">
          <a:avLst/>
        </a:prstGeom>
        <a:solidFill xmlns:a="http://schemas.openxmlformats.org/drawingml/2006/main">
          <a:schemeClr val="tx1"/>
        </a:solidFill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51624</cdr:x>
      <cdr:y>0.53245</cdr:y>
    </cdr:from>
    <cdr:to>
      <cdr:x>0.54113</cdr:x>
      <cdr:y>0.55538</cdr:y>
    </cdr:to>
    <cdr:sp macro="" textlink="">
      <cdr:nvSpPr>
        <cdr:cNvPr id="4" name="5-Point Star 3"/>
        <cdr:cNvSpPr/>
      </cdr:nvSpPr>
      <cdr:spPr>
        <a:xfrm xmlns:a="http://schemas.openxmlformats.org/drawingml/2006/main">
          <a:off x="4471837" y="3339620"/>
          <a:ext cx="215660" cy="143774"/>
        </a:xfrm>
        <a:prstGeom xmlns:a="http://schemas.openxmlformats.org/drawingml/2006/main" prst="star5">
          <a:avLst/>
        </a:prstGeom>
        <a:solidFill xmlns:a="http://schemas.openxmlformats.org/drawingml/2006/main">
          <a:schemeClr val="tx1"/>
        </a:solidFill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55773</cdr:x>
      <cdr:y>0.53245</cdr:y>
    </cdr:from>
    <cdr:to>
      <cdr:x>0.58263</cdr:x>
      <cdr:y>0.55538</cdr:y>
    </cdr:to>
    <cdr:sp macro="" textlink="">
      <cdr:nvSpPr>
        <cdr:cNvPr id="5" name="5-Point Star 4"/>
        <cdr:cNvSpPr/>
      </cdr:nvSpPr>
      <cdr:spPr>
        <a:xfrm xmlns:a="http://schemas.openxmlformats.org/drawingml/2006/main">
          <a:off x="4831271" y="3339621"/>
          <a:ext cx="215660" cy="143774"/>
        </a:xfrm>
        <a:prstGeom xmlns:a="http://schemas.openxmlformats.org/drawingml/2006/main" prst="star5">
          <a:avLst/>
        </a:prstGeom>
        <a:solidFill xmlns:a="http://schemas.openxmlformats.org/drawingml/2006/main">
          <a:schemeClr val="tx1"/>
        </a:solidFill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76105</cdr:x>
      <cdr:y>0.61841</cdr:y>
    </cdr:from>
    <cdr:to>
      <cdr:x>0.78595</cdr:x>
      <cdr:y>0.64134</cdr:y>
    </cdr:to>
    <cdr:sp macro="" textlink="">
      <cdr:nvSpPr>
        <cdr:cNvPr id="6" name="5-Point Star 5"/>
        <cdr:cNvSpPr/>
      </cdr:nvSpPr>
      <cdr:spPr>
        <a:xfrm xmlns:a="http://schemas.openxmlformats.org/drawingml/2006/main">
          <a:off x="6592498" y="3878772"/>
          <a:ext cx="215660" cy="143774"/>
        </a:xfrm>
        <a:prstGeom xmlns:a="http://schemas.openxmlformats.org/drawingml/2006/main" prst="star5">
          <a:avLst/>
        </a:prstGeom>
        <a:solidFill xmlns:a="http://schemas.openxmlformats.org/drawingml/2006/main">
          <a:schemeClr val="tx1"/>
        </a:solidFill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89176</cdr:x>
      <cdr:y>0.61268</cdr:y>
    </cdr:from>
    <cdr:to>
      <cdr:x>0.91665</cdr:x>
      <cdr:y>0.63561</cdr:y>
    </cdr:to>
    <cdr:sp macro="" textlink="">
      <cdr:nvSpPr>
        <cdr:cNvPr id="7" name="5-Point Star 6"/>
        <cdr:cNvSpPr/>
      </cdr:nvSpPr>
      <cdr:spPr>
        <a:xfrm xmlns:a="http://schemas.openxmlformats.org/drawingml/2006/main">
          <a:off x="7724715" y="3842828"/>
          <a:ext cx="215660" cy="143774"/>
        </a:xfrm>
        <a:prstGeom xmlns:a="http://schemas.openxmlformats.org/drawingml/2006/main" prst="star5">
          <a:avLst/>
        </a:prstGeom>
        <a:solidFill xmlns:a="http://schemas.openxmlformats.org/drawingml/2006/main">
          <a:schemeClr val="tx1"/>
        </a:solidFill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93947</cdr:x>
      <cdr:y>0.61268</cdr:y>
    </cdr:from>
    <cdr:to>
      <cdr:x>0.96437</cdr:x>
      <cdr:y>0.63561</cdr:y>
    </cdr:to>
    <cdr:sp macro="" textlink="">
      <cdr:nvSpPr>
        <cdr:cNvPr id="8" name="5-Point Star 7"/>
        <cdr:cNvSpPr/>
      </cdr:nvSpPr>
      <cdr:spPr>
        <a:xfrm xmlns:a="http://schemas.openxmlformats.org/drawingml/2006/main">
          <a:off x="8138064" y="3842828"/>
          <a:ext cx="215660" cy="143774"/>
        </a:xfrm>
        <a:prstGeom xmlns:a="http://schemas.openxmlformats.org/drawingml/2006/main" prst="star5">
          <a:avLst/>
        </a:prstGeom>
        <a:solidFill xmlns:a="http://schemas.openxmlformats.org/drawingml/2006/main">
          <a:schemeClr val="tx1"/>
        </a:solidFill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67859</cdr:x>
      <cdr:y>0.60705</cdr:y>
    </cdr:from>
    <cdr:to>
      <cdr:x>0.70349</cdr:x>
      <cdr:y>0.62998</cdr:y>
    </cdr:to>
    <cdr:sp macro="" textlink="">
      <cdr:nvSpPr>
        <cdr:cNvPr id="9" name="5-Point Star 8"/>
        <cdr:cNvSpPr/>
      </cdr:nvSpPr>
      <cdr:spPr>
        <a:xfrm xmlns:a="http://schemas.openxmlformats.org/drawingml/2006/main">
          <a:off x="5878178" y="3807479"/>
          <a:ext cx="215692" cy="143819"/>
        </a:xfrm>
        <a:prstGeom xmlns:a="http://schemas.openxmlformats.org/drawingml/2006/main" prst="star5">
          <a:avLst/>
        </a:prstGeom>
        <a:solidFill xmlns:a="http://schemas.openxmlformats.org/drawingml/2006/main">
          <a:srgbClr val="FF0000"/>
        </a:solidFill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55643</cdr:x>
      <cdr:y>0.5</cdr:y>
    </cdr:from>
    <cdr:to>
      <cdr:x>0.58133</cdr:x>
      <cdr:y>0.52293</cdr:y>
    </cdr:to>
    <cdr:sp macro="" textlink="">
      <cdr:nvSpPr>
        <cdr:cNvPr id="10" name="5-Point Star 9"/>
        <cdr:cNvSpPr/>
      </cdr:nvSpPr>
      <cdr:spPr>
        <a:xfrm xmlns:a="http://schemas.openxmlformats.org/drawingml/2006/main">
          <a:off x="4820024" y="3136061"/>
          <a:ext cx="215692" cy="143819"/>
        </a:xfrm>
        <a:prstGeom xmlns:a="http://schemas.openxmlformats.org/drawingml/2006/main" prst="star5">
          <a:avLst/>
        </a:prstGeom>
        <a:solidFill xmlns:a="http://schemas.openxmlformats.org/drawingml/2006/main">
          <a:srgbClr val="FF0000"/>
        </a:solidFill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60135</cdr:x>
      <cdr:y>0.54691</cdr:y>
    </cdr:from>
    <cdr:to>
      <cdr:x>0.62625</cdr:x>
      <cdr:y>0.56984</cdr:y>
    </cdr:to>
    <cdr:sp macro="" textlink="">
      <cdr:nvSpPr>
        <cdr:cNvPr id="12" name="5-Point Star 11"/>
        <cdr:cNvSpPr/>
      </cdr:nvSpPr>
      <cdr:spPr>
        <a:xfrm xmlns:a="http://schemas.openxmlformats.org/drawingml/2006/main">
          <a:off x="5209132" y="3430262"/>
          <a:ext cx="215692" cy="143819"/>
        </a:xfrm>
        <a:prstGeom xmlns:a="http://schemas.openxmlformats.org/drawingml/2006/main" prst="star5">
          <a:avLst/>
        </a:prstGeom>
        <a:solidFill xmlns:a="http://schemas.openxmlformats.org/drawingml/2006/main">
          <a:srgbClr val="FF0000"/>
        </a:solidFill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24649</cdr:x>
      <cdr:y>0.11109</cdr:y>
    </cdr:from>
    <cdr:to>
      <cdr:x>0.27139</cdr:x>
      <cdr:y>0.13402</cdr:y>
    </cdr:to>
    <cdr:sp macro="" textlink="">
      <cdr:nvSpPr>
        <cdr:cNvPr id="13" name="5-Point Star 12"/>
        <cdr:cNvSpPr/>
      </cdr:nvSpPr>
      <cdr:spPr>
        <a:xfrm xmlns:a="http://schemas.openxmlformats.org/drawingml/2006/main">
          <a:off x="2135190" y="696789"/>
          <a:ext cx="215692" cy="143819"/>
        </a:xfrm>
        <a:prstGeom xmlns:a="http://schemas.openxmlformats.org/drawingml/2006/main" prst="star5">
          <a:avLst/>
        </a:prstGeom>
        <a:solidFill xmlns:a="http://schemas.openxmlformats.org/drawingml/2006/main">
          <a:srgbClr val="FF0000"/>
        </a:solidFill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26334</cdr:x>
      <cdr:y>0.33443</cdr:y>
    </cdr:from>
    <cdr:to>
      <cdr:x>0.28824</cdr:x>
      <cdr:y>0.35736</cdr:y>
    </cdr:to>
    <cdr:sp macro="" textlink="">
      <cdr:nvSpPr>
        <cdr:cNvPr id="14" name="5-Point Star 13"/>
        <cdr:cNvSpPr/>
      </cdr:nvSpPr>
      <cdr:spPr>
        <a:xfrm xmlns:a="http://schemas.openxmlformats.org/drawingml/2006/main">
          <a:off x="2281106" y="2097573"/>
          <a:ext cx="215692" cy="143819"/>
        </a:xfrm>
        <a:prstGeom xmlns:a="http://schemas.openxmlformats.org/drawingml/2006/main" prst="star5">
          <a:avLst/>
        </a:prstGeom>
        <a:solidFill xmlns:a="http://schemas.openxmlformats.org/drawingml/2006/main">
          <a:srgbClr val="FF0000"/>
        </a:solidFill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63729</cdr:x>
      <cdr:y>0.58162</cdr:y>
    </cdr:from>
    <cdr:to>
      <cdr:x>0.66219</cdr:x>
      <cdr:y>0.60455</cdr:y>
    </cdr:to>
    <cdr:sp macro="" textlink="">
      <cdr:nvSpPr>
        <cdr:cNvPr id="15" name="5-Point Star 14"/>
        <cdr:cNvSpPr/>
      </cdr:nvSpPr>
      <cdr:spPr>
        <a:xfrm xmlns:a="http://schemas.openxmlformats.org/drawingml/2006/main">
          <a:off x="5520417" y="3648021"/>
          <a:ext cx="215692" cy="143819"/>
        </a:xfrm>
        <a:prstGeom xmlns:a="http://schemas.openxmlformats.org/drawingml/2006/main" prst="star5">
          <a:avLst/>
        </a:prstGeom>
        <a:solidFill xmlns:a="http://schemas.openxmlformats.org/drawingml/2006/main">
          <a:srgbClr val="FF0000"/>
        </a:solidFill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17574</cdr:x>
      <cdr:y>0.10644</cdr:y>
    </cdr:from>
    <cdr:to>
      <cdr:x>0.20064</cdr:x>
      <cdr:y>0.12937</cdr:y>
    </cdr:to>
    <cdr:sp macro="" textlink="">
      <cdr:nvSpPr>
        <cdr:cNvPr id="16" name="5-Point Star 15"/>
        <cdr:cNvSpPr/>
      </cdr:nvSpPr>
      <cdr:spPr>
        <a:xfrm xmlns:a="http://schemas.openxmlformats.org/drawingml/2006/main">
          <a:off x="1522348" y="667607"/>
          <a:ext cx="215692" cy="143819"/>
        </a:xfrm>
        <a:prstGeom xmlns:a="http://schemas.openxmlformats.org/drawingml/2006/main" prst="star5">
          <a:avLst/>
        </a:prstGeom>
        <a:solidFill xmlns:a="http://schemas.openxmlformats.org/drawingml/2006/main">
          <a:srgbClr val="FF0000"/>
        </a:solidFill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29831</cdr:x>
      <cdr:y>0.34373</cdr:y>
    </cdr:from>
    <cdr:to>
      <cdr:x>0.32321</cdr:x>
      <cdr:y>0.36666</cdr:y>
    </cdr:to>
    <cdr:sp macro="" textlink="">
      <cdr:nvSpPr>
        <cdr:cNvPr id="17" name="5-Point Star 16"/>
        <cdr:cNvSpPr/>
      </cdr:nvSpPr>
      <cdr:spPr>
        <a:xfrm xmlns:a="http://schemas.openxmlformats.org/drawingml/2006/main">
          <a:off x="2584047" y="2155938"/>
          <a:ext cx="215692" cy="143819"/>
        </a:xfrm>
        <a:prstGeom xmlns:a="http://schemas.openxmlformats.org/drawingml/2006/main" prst="star5">
          <a:avLst/>
        </a:prstGeom>
        <a:solidFill xmlns:a="http://schemas.openxmlformats.org/drawingml/2006/main">
          <a:srgbClr val="FF0000"/>
        </a:solidFill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34307</cdr:x>
      <cdr:y>0.41197</cdr:y>
    </cdr:from>
    <cdr:to>
      <cdr:x>0.36797</cdr:x>
      <cdr:y>0.4349</cdr:y>
    </cdr:to>
    <cdr:sp macro="" textlink="">
      <cdr:nvSpPr>
        <cdr:cNvPr id="18" name="5-Point Star 17"/>
        <cdr:cNvSpPr/>
      </cdr:nvSpPr>
      <cdr:spPr>
        <a:xfrm xmlns:a="http://schemas.openxmlformats.org/drawingml/2006/main">
          <a:off x="2971769" y="2583955"/>
          <a:ext cx="215692" cy="143819"/>
        </a:xfrm>
        <a:prstGeom xmlns:a="http://schemas.openxmlformats.org/drawingml/2006/main" prst="star5">
          <a:avLst/>
        </a:prstGeom>
        <a:solidFill xmlns:a="http://schemas.openxmlformats.org/drawingml/2006/main">
          <a:srgbClr val="FF0000"/>
        </a:solidFill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BA0860-CD0F-4111-A88D-97823E48FAA2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26E606-3D27-4AB1-8873-A0DD79BBB6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1197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426E606-3D27-4AB1-8873-A0DD79BBB60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9689270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Increased expression in </a:t>
            </a:r>
            <a:r>
              <a:rPr lang="en-US" dirty="0" err="1" smtClean="0"/>
              <a:t>iMPC</a:t>
            </a:r>
            <a:r>
              <a:rPr lang="en-US" dirty="0" smtClean="0"/>
              <a:t> </a:t>
            </a:r>
            <a:r>
              <a:rPr lang="en-US" smtClean="0"/>
              <a:t>(Stockholm data set). 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426E606-3D27-4AB1-8873-A0DD79BBB60F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33725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ELAVL3; mRNA stability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426E606-3D27-4AB1-8873-A0DD79BBB60F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147750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QKI; mRNA stability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426E606-3D27-4AB1-8873-A0DD79BBB60F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34342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HDRBS2; mRNA splicing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426E606-3D27-4AB1-8873-A0DD79BBB60F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079980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R (HIV-1) RNA binding protein 2 (TARBP2), transcript variant 1;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quired for formation of the RNA induced silencing complex (RISC)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426E606-3D27-4AB1-8873-A0DD79BBB60F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170425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BFC2B; NABP2;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mponent of the SOSS complex, a multiprotein complex that functions downstream of the MRN complex to promote DNA repair and G2/M checkpoint. In the SOSS complex, acts as a sensor of single-stranded DNA that binds to single-stranded DNA, in particular to </a:t>
            </a:r>
            <a:r>
              <a:rPr lang="en-US" sz="1200" b="0" i="0" u="none" strike="noStrike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olypyrimidines</a:t>
            </a:r>
            <a:r>
              <a:rPr lang="en-US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The SOSS complex associates with DNA lesions and influences diverse endpoints in the cellular DNA damage response including cell-cycle checkpoint activation, </a:t>
            </a:r>
            <a:r>
              <a:rPr lang="en-US" sz="1200" b="0" i="0" u="none" strike="noStrike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combinational</a:t>
            </a:r>
            <a:r>
              <a:rPr lang="en-US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pair and maintenance of genomic stability. Required for efficient homologous recombination-dependent repair of double-strand breaks (DSBs) and ATM-dependent signaling pathways.</a:t>
            </a:r>
            <a:r>
              <a:rPr lang="en-US" dirty="0" smtClean="0"/>
              <a:t> </a:t>
            </a:r>
            <a:r>
              <a:rPr lang="en-US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sDNA-binding protein</a:t>
            </a:r>
            <a:r>
              <a:rPr lang="en-US" dirty="0" smtClean="0"/>
              <a:t> </a:t>
            </a:r>
            <a:r>
              <a:rPr lang="en-US" sz="1200" b="1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NA repair</a:t>
            </a:r>
            <a:r>
              <a:rPr lang="en-US" dirty="0" smtClean="0"/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426E606-3D27-4AB1-8873-A0DD79BBB60F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960920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ZNF533; ZNF385B;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y play a role in p53/TP53-mediated apoptosis</a:t>
            </a:r>
            <a:r>
              <a:rPr lang="en-US" dirty="0" smtClean="0"/>
              <a:t> </a:t>
            </a:r>
            <a:r>
              <a:rPr lang="en-US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teracts with p53/TP53; the interaction is direct.</a:t>
            </a:r>
            <a:r>
              <a:rPr lang="en-US" dirty="0" smtClean="0"/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426E606-3D27-4AB1-8873-A0DD79BBB60F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468575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TYH2; </a:t>
            </a:r>
            <a:r>
              <a:rPr lang="en-US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encoded protein functions as a calcium(2+)-activated large conductance chloride(-) channel;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426E606-3D27-4AB1-8873-A0DD79BBB60F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627956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CNAB1;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tassium voltage-gated channel, shaker-related subfamily;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426E606-3D27-4AB1-8873-A0DD79BBB60F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0016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8569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804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584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812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39024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8812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0651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2374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3466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633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C0C0-B12A-4BA8-8A83-1D012D019158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7444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65C0C0-B12A-4BA8-8A83-1D012D019158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CB4C7F-67AB-4CD2-85B5-72AB5B0D5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844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7531" y="1438146"/>
            <a:ext cx="10515600" cy="3423104"/>
          </a:xfrm>
        </p:spPr>
        <p:txBody>
          <a:bodyPr>
            <a:normAutofit/>
          </a:bodyPr>
          <a:lstStyle/>
          <a:p>
            <a:pPr algn="ctr"/>
            <a:r>
              <a:rPr lang="en-US" b="1" dirty="0" smtClean="0"/>
              <a:t>Supplemental Figure S3. </a:t>
            </a:r>
            <a:r>
              <a:rPr lang="en-US" dirty="0" smtClean="0"/>
              <a:t>A sub-family of SCARS-encoded RNA molecules defined as Human Pluripotency Associated Transcripts (HPAT) binds a common set of 18 proteins in </a:t>
            </a:r>
            <a:r>
              <a:rPr lang="en-US" dirty="0" smtClean="0"/>
              <a:t>human induced pluripotent stem cells (iPSC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0268688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0125" y="571500"/>
            <a:ext cx="10191750" cy="5715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694653" y="987570"/>
            <a:ext cx="5278148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i="1" dirty="0" smtClean="0"/>
              <a:t>NABP2</a:t>
            </a:r>
          </a:p>
          <a:p>
            <a:pPr algn="ctr"/>
            <a:r>
              <a:rPr lang="en-US" sz="1600" dirty="0"/>
              <a:t>In the SOSS complex, acts as a sensor of single-stranded </a:t>
            </a:r>
            <a:r>
              <a:rPr lang="en-US" sz="1600" dirty="0" smtClean="0"/>
              <a:t>DNA. </a:t>
            </a:r>
          </a:p>
          <a:p>
            <a:pPr algn="ctr"/>
            <a:r>
              <a:rPr lang="en-US" sz="1600" dirty="0"/>
              <a:t>B</a:t>
            </a:r>
            <a:r>
              <a:rPr lang="en-US" sz="1600" dirty="0" smtClean="0"/>
              <a:t>inds </a:t>
            </a:r>
            <a:r>
              <a:rPr lang="en-US" sz="1600" dirty="0"/>
              <a:t>to single-stranded </a:t>
            </a:r>
            <a:r>
              <a:rPr lang="en-US" sz="1600" dirty="0" smtClean="0"/>
              <a:t>DNA during DNA damage repair; </a:t>
            </a:r>
          </a:p>
          <a:p>
            <a:pPr algn="ctr"/>
            <a:r>
              <a:rPr lang="en-US" sz="1600" dirty="0" smtClean="0"/>
              <a:t>homologous recombination; G2/M checkpoint.</a:t>
            </a:r>
            <a:endParaRPr lang="en-US" sz="1600" b="1" i="1" dirty="0" smtClean="0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73014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0125" y="571500"/>
            <a:ext cx="10191750" cy="5715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228307" y="1011382"/>
            <a:ext cx="4322402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i="1" dirty="0" smtClean="0"/>
              <a:t>ZNF385B</a:t>
            </a:r>
          </a:p>
          <a:p>
            <a:pPr algn="ctr"/>
            <a:r>
              <a:rPr lang="en-US" sz="2000" dirty="0" smtClean="0"/>
              <a:t>Directly interacts </a:t>
            </a:r>
            <a:r>
              <a:rPr lang="en-US" sz="2000" dirty="0"/>
              <a:t>with </a:t>
            </a:r>
            <a:r>
              <a:rPr lang="en-US" sz="2000" dirty="0" smtClean="0"/>
              <a:t>p53/TP53 &amp; play</a:t>
            </a:r>
          </a:p>
          <a:p>
            <a:pPr algn="ctr"/>
            <a:r>
              <a:rPr lang="en-US" sz="2000" dirty="0"/>
              <a:t>a</a:t>
            </a:r>
            <a:r>
              <a:rPr lang="en-US" sz="2000" dirty="0" smtClean="0"/>
              <a:t> role in p53/TP53-mediated apoptosis</a:t>
            </a:r>
            <a:endParaRPr lang="en-US" sz="2000" dirty="0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25734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0125" y="571500"/>
            <a:ext cx="10191750" cy="5715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972014" y="1316182"/>
            <a:ext cx="4015395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i="1" dirty="0" smtClean="0"/>
              <a:t>TTYH2</a:t>
            </a:r>
          </a:p>
          <a:p>
            <a:pPr algn="ctr"/>
            <a:r>
              <a:rPr lang="en-US" sz="2000" dirty="0" smtClean="0"/>
              <a:t>Calcium</a:t>
            </a:r>
            <a:r>
              <a:rPr lang="en-US" sz="2000" baseline="30000" dirty="0" smtClean="0"/>
              <a:t>2+</a:t>
            </a:r>
            <a:r>
              <a:rPr lang="en-US" sz="2000" dirty="0" smtClean="0"/>
              <a:t>-activated </a:t>
            </a:r>
            <a:r>
              <a:rPr lang="en-US" sz="2000" dirty="0"/>
              <a:t>large </a:t>
            </a:r>
            <a:endParaRPr lang="en-US" sz="2000" dirty="0" smtClean="0"/>
          </a:p>
          <a:p>
            <a:pPr algn="ctr"/>
            <a:r>
              <a:rPr lang="en-US" sz="2000" dirty="0" smtClean="0"/>
              <a:t>conductance chloride anion channel.</a:t>
            </a:r>
            <a:endParaRPr lang="en-US" sz="2000" b="1" i="1" dirty="0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14337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0125" y="571500"/>
            <a:ext cx="10191750" cy="5715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680364" y="1316182"/>
            <a:ext cx="3745128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i="1" dirty="0" smtClean="0"/>
              <a:t>KCNAB1</a:t>
            </a:r>
          </a:p>
          <a:p>
            <a:pPr algn="ctr"/>
            <a:r>
              <a:rPr lang="en-US" sz="2000" dirty="0" smtClean="0"/>
              <a:t>Potassium </a:t>
            </a:r>
            <a:r>
              <a:rPr lang="en-US" sz="2000" dirty="0"/>
              <a:t>voltage-gated </a:t>
            </a:r>
            <a:r>
              <a:rPr lang="en-US" sz="2000" dirty="0" smtClean="0"/>
              <a:t>channel. </a:t>
            </a:r>
            <a:endParaRPr lang="en-US" sz="2000" b="1" i="1" dirty="0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41453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4401" y="2275073"/>
            <a:ext cx="10691609" cy="1325563"/>
          </a:xfrm>
        </p:spPr>
        <p:txBody>
          <a:bodyPr>
            <a:normAutofit/>
          </a:bodyPr>
          <a:lstStyle/>
          <a:p>
            <a:r>
              <a:rPr lang="en-US" sz="4000" b="1" dirty="0" smtClean="0"/>
              <a:t>Examples of other SCARS networks genes of interest</a:t>
            </a:r>
            <a:endParaRPr lang="en-US" sz="4000" b="1" dirty="0"/>
          </a:p>
        </p:txBody>
      </p:sp>
      <p:sp>
        <p:nvSpPr>
          <p:cNvPr id="3" name="TextBox 2"/>
          <p:cNvSpPr txBox="1"/>
          <p:nvPr/>
        </p:nvSpPr>
        <p:spPr>
          <a:xfrm>
            <a:off x="0" y="0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99334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0125" y="571500"/>
            <a:ext cx="10191750" cy="5715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135786" y="1011382"/>
            <a:ext cx="552279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i="1" dirty="0" smtClean="0"/>
              <a:t>ZNF534</a:t>
            </a:r>
          </a:p>
          <a:p>
            <a:pPr algn="ctr"/>
            <a:r>
              <a:rPr lang="en-US" sz="2000" dirty="0" smtClean="0"/>
              <a:t>Main regulator of HERVH expression in human cell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94066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0125" y="571500"/>
            <a:ext cx="10191750" cy="5715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254062" y="1316182"/>
            <a:ext cx="459773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i="1" dirty="0" smtClean="0"/>
              <a:t>LINC00657 (NORAD)</a:t>
            </a:r>
          </a:p>
          <a:p>
            <a:pPr algn="ctr"/>
            <a:r>
              <a:rPr lang="en-US" sz="2000" dirty="0" smtClean="0"/>
              <a:t>Noncoding RNA activated by </a:t>
            </a:r>
            <a:r>
              <a:rPr lang="en-US" sz="2000" dirty="0"/>
              <a:t>D</a:t>
            </a:r>
            <a:r>
              <a:rPr lang="en-US" sz="2000" dirty="0" smtClean="0"/>
              <a:t>NA damage </a:t>
            </a:r>
            <a:endParaRPr lang="en-US" sz="2000" b="1" i="1" dirty="0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42255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38946" y="216441"/>
            <a:ext cx="4932218" cy="6450711"/>
          </a:xfrm>
          <a:prstGeom prst="rect">
            <a:avLst/>
          </a:prstGeom>
        </p:spPr>
      </p:pic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80184994"/>
              </p:ext>
            </p:extLst>
          </p:nvPr>
        </p:nvGraphicFramePr>
        <p:xfrm>
          <a:off x="345233" y="3825550"/>
          <a:ext cx="1562532" cy="158252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62532"/>
              </a:tblGrid>
              <a:tr h="3545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EY GENE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30699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AD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30699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M1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30699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M2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30699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solidFill>
                            <a:srgbClr val="00B0F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ffect of SCARS?</a:t>
                      </a:r>
                      <a:endParaRPr lang="en-US" sz="1400" b="1" i="0" u="none" strike="noStrike" dirty="0">
                        <a:solidFill>
                          <a:srgbClr val="00B0F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4" name="Flowchart: Merge 3"/>
          <p:cNvSpPr/>
          <p:nvPr/>
        </p:nvSpPr>
        <p:spPr>
          <a:xfrm rot="16200000">
            <a:off x="1832090" y="3901224"/>
            <a:ext cx="1582530" cy="1431182"/>
          </a:xfrm>
          <a:prstGeom prst="flowChartMerge">
            <a:avLst/>
          </a:prstGeom>
          <a:solidFill>
            <a:srgbClr val="00B0F0">
              <a:alpha val="11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85299974"/>
              </p:ext>
            </p:extLst>
          </p:nvPr>
        </p:nvGraphicFramePr>
        <p:xfrm>
          <a:off x="9257664" y="3841389"/>
          <a:ext cx="2405601" cy="156668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01867"/>
                <a:gridCol w="801867"/>
                <a:gridCol w="801867"/>
              </a:tblGrid>
              <a:tr h="21577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2 FC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251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P1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45883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5E-05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251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1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7659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7154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251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NCA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0611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98E-05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251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IP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26236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942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251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rgbClr val="00B0F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M1</a:t>
                      </a:r>
                      <a:endParaRPr lang="en-US" sz="1100" b="1" i="0" u="none" strike="noStrike" dirty="0">
                        <a:solidFill>
                          <a:srgbClr val="00B0F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30853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984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251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rgbClr val="00B0F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M2</a:t>
                      </a:r>
                      <a:endParaRPr lang="en-US" sz="1100" b="1" i="0" u="none" strike="noStrike" dirty="0">
                        <a:solidFill>
                          <a:srgbClr val="00B0F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30112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7682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  <p:sp>
        <p:nvSpPr>
          <p:cNvPr id="6" name="Flowchart: Merge 5"/>
          <p:cNvSpPr/>
          <p:nvPr/>
        </p:nvSpPr>
        <p:spPr>
          <a:xfrm rot="16200000">
            <a:off x="7750808" y="3901222"/>
            <a:ext cx="1582530" cy="1431182"/>
          </a:xfrm>
          <a:prstGeom prst="flowChartMerge">
            <a:avLst/>
          </a:prstGeom>
          <a:solidFill>
            <a:srgbClr val="00B0F0">
              <a:alpha val="11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9587468" y="3318169"/>
            <a:ext cx="1745991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ffects of SCARS </a:t>
            </a:r>
            <a:endParaRPr lang="en-US" sz="1400" b="1" dirty="0" smtClean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4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lencing </a:t>
            </a:r>
            <a:r>
              <a:rPr lang="en-US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sz="1400" b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SC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0" y="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34678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96526370"/>
              </p:ext>
            </p:extLst>
          </p:nvPr>
        </p:nvGraphicFramePr>
        <p:xfrm>
          <a:off x="1177637" y="1330037"/>
          <a:ext cx="9088581" cy="390464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253969"/>
                <a:gridCol w="2110211"/>
                <a:gridCol w="2770909"/>
                <a:gridCol w="900546"/>
                <a:gridCol w="1052946"/>
              </a:tblGrid>
              <a:tr h="29094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LME cells (n = 135)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bryonic cells (n = 1,394)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2 FC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69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WIL1</a:t>
                      </a:r>
                      <a:endParaRPr lang="en-US" sz="16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6296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39168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72369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7657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69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BEC3B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07407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26399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00028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5866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8020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AR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6.2222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7.7159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7792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24E-09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69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INC5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7.1185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2.1248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17285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88E-07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69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INC3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6.0148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9.462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23221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E-12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30262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00B0F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C00657 (NORAD)</a:t>
                      </a:r>
                      <a:endParaRPr lang="en-US" sz="1600" b="1" i="0" u="none" strike="noStrike" dirty="0">
                        <a:solidFill>
                          <a:srgbClr val="00B0F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6.2889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.72884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569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E-06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69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00B0F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M1</a:t>
                      </a:r>
                      <a:endParaRPr lang="en-US" sz="1600" b="1" i="0" u="none" strike="noStrike" dirty="0">
                        <a:solidFill>
                          <a:srgbClr val="00B0F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1.6222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2.7568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6796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79E-09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8020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00B0F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M2</a:t>
                      </a:r>
                      <a:endParaRPr lang="en-US" sz="1600" b="1" i="0" u="none" strike="noStrike" dirty="0">
                        <a:solidFill>
                          <a:srgbClr val="00B0F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4.3778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4.7453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7144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2E-07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8020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P1</a:t>
                      </a:r>
                      <a:endParaRPr lang="en-US" sz="16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88.607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4.0574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2837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9E-09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8020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1</a:t>
                      </a:r>
                      <a:endParaRPr lang="en-US" sz="16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2222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26686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37455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007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8020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</a:t>
                      </a:r>
                      <a:endParaRPr lang="en-US" sz="16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.28889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97561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22601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3232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8020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3</a:t>
                      </a:r>
                      <a:endParaRPr lang="en-US" sz="16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02222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43185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3954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9985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8020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IP</a:t>
                      </a:r>
                      <a:endParaRPr lang="en-US" sz="16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1.844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5.3257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4925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187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1177637" y="386624"/>
            <a:ext cx="9088581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 of selected SCARS-regulated genes in human embryonic </a:t>
            </a:r>
            <a:r>
              <a:rPr lang="en-US" sz="20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lti-lineage </a:t>
            </a:r>
            <a:r>
              <a:rPr lang="en-US" sz="2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rkers expressing (MLME) cells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94412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13746535"/>
              </p:ext>
            </p:extLst>
          </p:nvPr>
        </p:nvGraphicFramePr>
        <p:xfrm>
          <a:off x="1764082" y="284445"/>
          <a:ext cx="8663836" cy="62891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6736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49541818"/>
              </p:ext>
            </p:extLst>
          </p:nvPr>
        </p:nvGraphicFramePr>
        <p:xfrm>
          <a:off x="1764821" y="292938"/>
          <a:ext cx="8662358" cy="62721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Rectangle 2"/>
          <p:cNvSpPr/>
          <p:nvPr/>
        </p:nvSpPr>
        <p:spPr>
          <a:xfrm>
            <a:off x="4640698" y="1554080"/>
            <a:ext cx="38400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b="1" dirty="0"/>
              <a:t>Stars denote virus-interacting protein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6699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67577949"/>
              </p:ext>
            </p:extLst>
          </p:nvPr>
        </p:nvGraphicFramePr>
        <p:xfrm>
          <a:off x="1764821" y="292938"/>
          <a:ext cx="8662358" cy="62721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Rectangle 2"/>
          <p:cNvSpPr/>
          <p:nvPr/>
        </p:nvSpPr>
        <p:spPr>
          <a:xfrm>
            <a:off x="4348868" y="1554080"/>
            <a:ext cx="523309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b="1" dirty="0"/>
              <a:t>Stars denote virus-interacting </a:t>
            </a:r>
            <a:r>
              <a:rPr lang="en-US" b="1" dirty="0" smtClean="0"/>
              <a:t>proteins &amp; </a:t>
            </a:r>
          </a:p>
          <a:p>
            <a:pPr algn="ctr"/>
            <a:r>
              <a:rPr lang="en-US" b="1" dirty="0" smtClean="0">
                <a:solidFill>
                  <a:srgbClr val="FF0000"/>
                </a:solidFill>
              </a:rPr>
              <a:t>genes with prominent expression in the human brain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8345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09600" y="1510145"/>
            <a:ext cx="11125199" cy="1764290"/>
          </a:xfrm>
        </p:spPr>
        <p:txBody>
          <a:bodyPr>
            <a:normAutofit/>
          </a:bodyPr>
          <a:lstStyle/>
          <a:p>
            <a:r>
              <a:rPr lang="en-US" b="1" dirty="0"/>
              <a:t>RNA-</a:t>
            </a:r>
            <a:r>
              <a:rPr lang="en-US" b="1" dirty="0" err="1"/>
              <a:t>Seq</a:t>
            </a:r>
            <a:r>
              <a:rPr lang="en-US" b="1" dirty="0"/>
              <a:t> Expression Data from </a:t>
            </a:r>
            <a:r>
              <a:rPr lang="en-US" b="1" dirty="0" err="1"/>
              <a:t>GTEx</a:t>
            </a:r>
            <a:r>
              <a:rPr lang="en-US" b="1" dirty="0"/>
              <a:t> </a:t>
            </a:r>
            <a:br>
              <a:rPr lang="en-US" b="1" dirty="0"/>
            </a:br>
            <a:r>
              <a:rPr lang="en-US" b="1" dirty="0" smtClean="0"/>
              <a:t>(</a:t>
            </a:r>
            <a:r>
              <a:rPr lang="en-US" b="1" dirty="0"/>
              <a:t>53 </a:t>
            </a:r>
            <a:r>
              <a:rPr lang="en-US" b="1" dirty="0" smtClean="0"/>
              <a:t>Human Tissues</a:t>
            </a:r>
            <a:r>
              <a:rPr lang="en-US" b="1" dirty="0"/>
              <a:t>, </a:t>
            </a:r>
            <a:r>
              <a:rPr lang="en-US" b="1" dirty="0" smtClean="0"/>
              <a:t>570 </a:t>
            </a:r>
            <a:r>
              <a:rPr lang="en-US" b="1" dirty="0"/>
              <a:t>Donors)</a:t>
            </a:r>
            <a:r>
              <a:rPr lang="en-US" dirty="0"/>
              <a:t> 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30674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0125" y="571500"/>
            <a:ext cx="10191750" cy="5715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680364" y="1316182"/>
            <a:ext cx="1765612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i="1" dirty="0" smtClean="0"/>
              <a:t>ELAVL3</a:t>
            </a:r>
          </a:p>
          <a:p>
            <a:pPr algn="ctr"/>
            <a:r>
              <a:rPr lang="en-US" sz="2000" dirty="0" smtClean="0"/>
              <a:t>mRNA stability</a:t>
            </a:r>
            <a:endParaRPr lang="en-US" sz="2000" dirty="0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30034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0125" y="571500"/>
            <a:ext cx="10191750" cy="5715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680364" y="1316182"/>
            <a:ext cx="1765612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i="1" dirty="0" smtClean="0"/>
              <a:t>QKI</a:t>
            </a:r>
          </a:p>
          <a:p>
            <a:pPr algn="ctr"/>
            <a:r>
              <a:rPr lang="en-US" sz="2000" dirty="0" smtClean="0"/>
              <a:t>mRNA stability</a:t>
            </a:r>
            <a:endParaRPr lang="en-US" sz="2000" dirty="0"/>
          </a:p>
        </p:txBody>
      </p:sp>
      <p:sp>
        <p:nvSpPr>
          <p:cNvPr id="4" name="Rectangle 3"/>
          <p:cNvSpPr/>
          <p:nvPr/>
        </p:nvSpPr>
        <p:spPr>
          <a:xfrm>
            <a:off x="4833979" y="202168"/>
            <a:ext cx="26119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V</a:t>
            </a:r>
            <a:r>
              <a:rPr lang="en-US" b="1" dirty="0" smtClean="0"/>
              <a:t>irus-interacting protein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0" y="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69617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0125" y="571500"/>
            <a:ext cx="10191750" cy="5715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680364" y="1316182"/>
            <a:ext cx="171553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i="1" dirty="0" smtClean="0"/>
              <a:t>KHDRBS2</a:t>
            </a:r>
          </a:p>
          <a:p>
            <a:pPr algn="ctr"/>
            <a:r>
              <a:rPr lang="en-US" sz="2000" dirty="0" smtClean="0"/>
              <a:t>mRNA splicing</a:t>
            </a:r>
            <a:endParaRPr lang="en-US" sz="2000" dirty="0"/>
          </a:p>
        </p:txBody>
      </p:sp>
      <p:sp>
        <p:nvSpPr>
          <p:cNvPr id="4" name="TextBox 3"/>
          <p:cNvSpPr txBox="1"/>
          <p:nvPr/>
        </p:nvSpPr>
        <p:spPr>
          <a:xfrm>
            <a:off x="0" y="0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38882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0125" y="571500"/>
            <a:ext cx="10191750" cy="5715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274000" y="1302327"/>
            <a:ext cx="4821320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i="1" dirty="0" smtClean="0"/>
              <a:t>TARBP2</a:t>
            </a:r>
          </a:p>
          <a:p>
            <a:pPr algn="ctr"/>
            <a:r>
              <a:rPr lang="en-US" sz="2000" dirty="0"/>
              <a:t>Required for formation of the RNA induced </a:t>
            </a:r>
            <a:endParaRPr lang="en-US" sz="2000" dirty="0" smtClean="0"/>
          </a:p>
          <a:p>
            <a:pPr algn="ctr"/>
            <a:r>
              <a:rPr lang="en-US" sz="2000" dirty="0" smtClean="0"/>
              <a:t>silencing </a:t>
            </a:r>
            <a:r>
              <a:rPr lang="en-US" sz="2000" dirty="0"/>
              <a:t>complex (RISC). </a:t>
            </a:r>
            <a:endParaRPr lang="en-US" sz="2000" i="1" dirty="0"/>
          </a:p>
        </p:txBody>
      </p:sp>
      <p:sp>
        <p:nvSpPr>
          <p:cNvPr id="4" name="Rectangle 3"/>
          <p:cNvSpPr/>
          <p:nvPr/>
        </p:nvSpPr>
        <p:spPr>
          <a:xfrm>
            <a:off x="4790001" y="202168"/>
            <a:ext cx="26119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V</a:t>
            </a:r>
            <a:r>
              <a:rPr lang="en-US" b="1" dirty="0" smtClean="0"/>
              <a:t>irus-interacting protein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4245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7</TotalTime>
  <Words>555</Words>
  <Application>Microsoft Office PowerPoint</Application>
  <PresentationFormat>Widescreen</PresentationFormat>
  <Paragraphs>174</Paragraphs>
  <Slides>18</Slides>
  <Notes>1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2" baseType="lpstr">
      <vt:lpstr>Arial</vt:lpstr>
      <vt:lpstr>Calibri</vt:lpstr>
      <vt:lpstr>Calibri Light</vt:lpstr>
      <vt:lpstr>Office Theme</vt:lpstr>
      <vt:lpstr>Supplemental Figure S3. A sub-family of SCARS-encoded RNA molecules defined as Human Pluripotency Associated Transcripts (HPAT) binds a common set of 18 proteins in human induced pluripotent stem cells (iPSC).</vt:lpstr>
      <vt:lpstr>PowerPoint Presentation</vt:lpstr>
      <vt:lpstr>PowerPoint Presentation</vt:lpstr>
      <vt:lpstr>PowerPoint Presentation</vt:lpstr>
      <vt:lpstr>RNA-Seq Expression Data from GTEx  (53 Human Tissues, 570 Donors)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Examples of other SCARS networks genes of interest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hromatin structure</dc:title>
  <dc:creator>Guennadi Glinskii</dc:creator>
  <cp:lastModifiedBy>Guennadi Glinskii</cp:lastModifiedBy>
  <cp:revision>54</cp:revision>
  <dcterms:created xsi:type="dcterms:W3CDTF">2014-04-06T16:27:14Z</dcterms:created>
  <dcterms:modified xsi:type="dcterms:W3CDTF">2021-03-24T01:50:38Z</dcterms:modified>
</cp:coreProperties>
</file>